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14403388"/>
  <p:notesSz cx="7102475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1028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800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4440" y="0"/>
            <a:ext cx="307800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3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3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35320" y="767880"/>
            <a:ext cx="2433600" cy="3837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9000" rIns="99000" tIns="49680" bIns="49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11360" y="4861080"/>
            <a:ext cx="5682960" cy="460512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800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4440" y="9721800"/>
            <a:ext cx="307800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3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A8F07B1-DB45-436B-8565-DE32C4304165}" type="slidenum">
              <a:rPr b="0" lang="zh-TW" sz="13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2335320" y="768240"/>
            <a:ext cx="2433600" cy="383724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711360" y="4861080"/>
            <a:ext cx="568296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投影片編號版面配置區 3"/>
          <p:cNvSpPr/>
          <p:nvPr/>
        </p:nvSpPr>
        <p:spPr>
          <a:xfrm>
            <a:off x="4024440" y="9721800"/>
            <a:ext cx="307800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8D62CC-9CE1-456D-9D88-2C4FEEF71051}" type="slidenum">
              <a:rPr b="0" lang="zh-TW" sz="13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2106BA-D6AD-4E99-8846-4E85610E36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822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8324640"/>
            <a:ext cx="822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8D13E0-B707-47BF-8283-B1930FB062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33602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83246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83246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3F46DF-86B9-444F-AF82-57E165B956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264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3360240"/>
            <a:ext cx="264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3360240"/>
            <a:ext cx="264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8324640"/>
            <a:ext cx="264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8324640"/>
            <a:ext cx="264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8324640"/>
            <a:ext cx="264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A627F2-C37A-4C33-904A-AF283F6E403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3360240"/>
            <a:ext cx="8229600" cy="9504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0AC84F-171E-4B01-95D6-AF4F998E9B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82296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0626DD-5161-4A8E-A351-4BBA5D9D7C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40158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3360240"/>
            <a:ext cx="40158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65E790-C710-4C23-88DD-795BF5D832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9A91E8-9553-447C-944F-54E9897E25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576000"/>
            <a:ext cx="8229600" cy="11126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76922C-14E9-4624-AC1D-C19A631BA3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3360240"/>
            <a:ext cx="40158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83246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05C11C-5762-4326-B9F7-1B814B228C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40158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33602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83246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0CE33D-DA37-4959-AFAE-54F74998A0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33602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3360240"/>
            <a:ext cx="40158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8324640"/>
            <a:ext cx="8229600" cy="453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16405C-50B6-483F-A1B4-E28DFAF2AB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576000"/>
            <a:ext cx="8229600" cy="2400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3360240"/>
            <a:ext cx="8229600" cy="9504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13347720"/>
            <a:ext cx="2133720" cy="76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13347720"/>
            <a:ext cx="2895840" cy="76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13347720"/>
            <a:ext cx="2133720" cy="76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7BC68A-FD07-4B7A-B02F-65B420210E07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文字方塊 9"/>
          <p:cNvSpPr/>
          <p:nvPr/>
        </p:nvSpPr>
        <p:spPr>
          <a:xfrm>
            <a:off x="938520" y="3672000"/>
            <a:ext cx="593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Table S1. The primer sets for RT-qPCR detection of mRNA.  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49" name=""/>
          <p:cNvGraphicFramePr/>
          <p:nvPr/>
        </p:nvGraphicFramePr>
        <p:xfrm>
          <a:off x="971640" y="4176720"/>
          <a:ext cx="6773760" cy="3343320"/>
        </p:xfrm>
        <a:graphic>
          <a:graphicData uri="http://schemas.openxmlformats.org/drawingml/2006/table">
            <a:tbl>
              <a:tblPr/>
              <a:tblGrid>
                <a:gridCol w="1008000"/>
                <a:gridCol w="1295280"/>
                <a:gridCol w="4470480"/>
              </a:tblGrid>
              <a:tr h="371520">
                <a:tc gridSpan="2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imers for RT-qPCR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quence(5’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Wingdings"/>
                          <a:ea typeface="Wingdings"/>
                        </a:rPr>
                        <a:t>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’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 rowSpan="2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FL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ward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CCTCTggCgTTgAAgACT</a:t>
                      </a:r>
                      <a:r>
                        <a:rPr b="0" lang="zh-TW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vers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TgCCCTCTCCTTTTCgTTT</a:t>
                      </a:r>
                      <a:r>
                        <a:rPr b="0" lang="zh-TW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160">
                <a:tc rowSpan="2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KN1B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ward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CTCgCCAgTCCAT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vers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AAAACCgAACAAAACAAAg</a:t>
                      </a:r>
                      <a:r>
                        <a:rPr b="0" lang="zh-TW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 rowSpan="2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EAD1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ward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gAggCCCTggCTATCTATC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vers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ggCCTTATCCTTTgCAg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 rowSpan="2"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PDH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ward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ATCCCATCACCATCTTCC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vers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gACTCCACgACgTACTC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68400" marR="684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9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23T06:15:08Z</dcterms:created>
  <dc:creator>Tchan</dc:creator>
  <dc:description/>
  <dc:language>en-US</dc:language>
  <cp:lastModifiedBy>YJ Lee</cp:lastModifiedBy>
  <dcterms:modified xsi:type="dcterms:W3CDTF">2017-03-12T18:23:09Z</dcterms:modified>
  <cp:revision>1071</cp:revision>
  <dc:subject/>
  <dc:title>投影片 1</dc:title>
</cp:coreProperties>
</file>